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4" autoAdjust="0"/>
    <p:restoredTop sz="94660"/>
  </p:normalViewPr>
  <p:slideViewPr>
    <p:cSldViewPr snapToGrid="0">
      <p:cViewPr varScale="1">
        <p:scale>
          <a:sx n="131" d="100"/>
          <a:sy n="131" d="100"/>
        </p:scale>
        <p:origin x="416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70A610-3C83-408E-8630-1A74ACD3050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6B45BAD-4983-420E-828A-5114CD537B9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F1828B-F6BB-4BC4-889A-0A42D287E5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465226-F44F-4899-8961-D7531151222C}" type="datetimeFigureOut">
              <a:rPr lang="en-US" smtClean="0"/>
              <a:t>10/12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F3EA4F2-11AC-46D9-AA8D-8C68512EAE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3220A29-B0EC-493A-9582-5ACF959EBA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5DDCF-D08F-4E64-A45D-1ACE21BAA4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7199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3DE805-004C-4215-8EFF-C5C884E5DC4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A4FBA5D-95A5-4AD2-BE9A-20EC0591559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075DD17-30C9-4F04-BDBF-5DC4C9FD7C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465226-F44F-4899-8961-D7531151222C}" type="datetimeFigureOut">
              <a:rPr lang="en-US" smtClean="0"/>
              <a:t>10/12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E775AF7-730E-4EE8-AAD6-8EEE88BC41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58FABA5-9D39-4856-ABE6-7D1DBF2683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5DDCF-D08F-4E64-A45D-1ACE21BAA4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16025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72679D0-A98F-4195-97A1-A6C6F3FCFE4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DFEAA96-F856-4FE3-958E-39B8D7A4A2C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AE978F8-8F95-41F1-95C7-968F6C92BE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465226-F44F-4899-8961-D7531151222C}" type="datetimeFigureOut">
              <a:rPr lang="en-US" smtClean="0"/>
              <a:t>10/12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2E3A21E-7329-4F11-AFE0-24CB6AC71F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AC13EAB-92F1-4257-9698-1E7CBDE05D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5DDCF-D08F-4E64-A45D-1ACE21BAA4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96681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49C745-7B8D-4F71-BE69-FA6785B1667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8084AFD-9ACF-45B6-A59D-AE677640B05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32F63F3-2DBF-474F-87F8-289A96CB4E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465226-F44F-4899-8961-D7531151222C}" type="datetimeFigureOut">
              <a:rPr lang="en-US" smtClean="0"/>
              <a:t>10/12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442C223-9A63-4ACA-8934-6B2B23D887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61E7A10-498A-4AB3-BF85-ABF01DF62B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5DDCF-D08F-4E64-A45D-1ACE21BAA4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04394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C22BCD-D0C5-481C-A474-222F617BB8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2BE0B26-41BF-43D4-B4CC-5E23CE5E280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F760086-CC33-440B-BED0-33317E273F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465226-F44F-4899-8961-D7531151222C}" type="datetimeFigureOut">
              <a:rPr lang="en-US" smtClean="0"/>
              <a:t>10/12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2044952-FAF1-4AEF-AE41-871C39CCBA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0A886DC-8CC7-4E96-9FA6-99E17C241F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5DDCF-D08F-4E64-A45D-1ACE21BAA4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83786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8E8AE8-661D-4ED4-8632-179326FDA92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40BA954-713E-4B93-A2D6-A52381524C1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FC25284-EE81-477C-8EEB-5B6576B68A7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EC6EC9D-2C8D-423A-B431-0A162B4E0D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465226-F44F-4899-8961-D7531151222C}" type="datetimeFigureOut">
              <a:rPr lang="en-US" smtClean="0"/>
              <a:t>10/12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B404AC9-7652-463B-9197-07F79C7858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DAAE221-9A91-4C7F-AD10-09E8D8C8C0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5DDCF-D08F-4E64-A45D-1ACE21BAA4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63255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880893-18F0-496F-A71C-3906853A1F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05F39CE-43BE-4B3C-B173-9B258F54038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F6ED538-0227-40C3-8534-AE7E54E6063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ECBA4EA-2825-42EE-8EAB-23F7FC00B1A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983636C-7822-4732-861F-9F54C6FDF28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E503C0D-D895-420E-8F22-5CA4D85F34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465226-F44F-4899-8961-D7531151222C}" type="datetimeFigureOut">
              <a:rPr lang="en-US" smtClean="0"/>
              <a:t>10/12/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5F416A0-3514-433D-9D1A-81E664BDE7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787F8F8-23E3-4E58-9F2F-FC17062379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5DDCF-D08F-4E64-A45D-1ACE21BAA4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25666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CAC08AE-19D8-4130-86C6-4FA99D792F8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F7AE7F9-6ED4-4DAE-9C19-A52B97F1C2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465226-F44F-4899-8961-D7531151222C}" type="datetimeFigureOut">
              <a:rPr lang="en-US" smtClean="0"/>
              <a:t>10/12/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98DFFC1-D5EC-4FA7-9555-18BA702449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A314271-EB92-4090-B222-DD2C83B391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5DDCF-D08F-4E64-A45D-1ACE21BAA4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92358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E346CF6-1489-47B6-99D4-5BAAE075EB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465226-F44F-4899-8961-D7531151222C}" type="datetimeFigureOut">
              <a:rPr lang="en-US" smtClean="0"/>
              <a:t>10/12/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973816D-4A6E-44E8-A6B6-9E1C9FA814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AC29613-0B02-45F8-A59B-BB2E552486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5DDCF-D08F-4E64-A45D-1ACE21BAA4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27556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F4B609-8287-4E73-826A-3EC7062573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02D718D-0039-4186-B7C8-BCE18A121F5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0A81590-B40B-44F8-B14E-25135AFCABD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E81591F-8541-49E1-9A3C-07F98CA8C2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465226-F44F-4899-8961-D7531151222C}" type="datetimeFigureOut">
              <a:rPr lang="en-US" smtClean="0"/>
              <a:t>10/12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DA73069-6DE8-4DAE-B6A7-B3FCFA5B24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132463E-DB38-4D89-BE81-3E43625116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5DDCF-D08F-4E64-A45D-1ACE21BAA4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24476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BE5B05-E759-468D-BBC6-F9AF3D94D1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54914CD-2AAC-4855-8EC0-31131A59B1F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131F57D-1B28-4299-A07E-F05BA6DE97C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3E6DB4F-79C4-4AB0-B1A0-9E1FE6ED87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465226-F44F-4899-8961-D7531151222C}" type="datetimeFigureOut">
              <a:rPr lang="en-US" smtClean="0"/>
              <a:t>10/12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F8562FF-0D71-488E-BF97-74A15B104A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C6D36E6-E770-42F3-9399-7B39353234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5DDCF-D08F-4E64-A45D-1ACE21BAA4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33426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676D41F-B4EB-4357-B9BD-4D813832057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08B1CC3-F762-47FC-9E10-2D6B95B1AC3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5CE0791-D594-4AF2-B154-030306C755A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465226-F44F-4899-8961-D7531151222C}" type="datetimeFigureOut">
              <a:rPr lang="en-US" smtClean="0"/>
              <a:t>10/12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7CA6FDB-C36A-42BB-8131-AAF01B06F16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C9489C7-71AE-4910-B0FD-E4BB39B72D3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C5DDCF-D08F-4E64-A45D-1ACE21BAA4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8288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E0AD3581-5423-4A04-B540-A265CE564609}"/>
              </a:ext>
            </a:extLst>
          </p:cNvPr>
          <p:cNvSpPr txBox="1"/>
          <p:nvPr/>
        </p:nvSpPr>
        <p:spPr>
          <a:xfrm>
            <a:off x="102637" y="1780790"/>
            <a:ext cx="36260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7BB21DD7-FF53-4172-8F79-F571F7741F8A}"/>
              </a:ext>
            </a:extLst>
          </p:cNvPr>
          <p:cNvSpPr txBox="1"/>
          <p:nvPr/>
        </p:nvSpPr>
        <p:spPr>
          <a:xfrm>
            <a:off x="4122748" y="1778645"/>
            <a:ext cx="35137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B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006DACBD-5505-4D6B-90FE-0005A175D6E4}"/>
              </a:ext>
            </a:extLst>
          </p:cNvPr>
          <p:cNvSpPr txBox="1"/>
          <p:nvPr/>
        </p:nvSpPr>
        <p:spPr>
          <a:xfrm>
            <a:off x="8131637" y="1778644"/>
            <a:ext cx="34817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C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12409F87-CC83-41A8-A969-2D3188822055}"/>
              </a:ext>
            </a:extLst>
          </p:cNvPr>
          <p:cNvSpPr txBox="1"/>
          <p:nvPr/>
        </p:nvSpPr>
        <p:spPr>
          <a:xfrm>
            <a:off x="548951" y="4954556"/>
            <a:ext cx="1129937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S1. The Ct value among different experimental conditions on different time points for housekeeping genes 40s rps17 (A), actin (B), and rpL5 (C).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B1BB0BC5-18C4-4419-9F9D-CB5A817F97E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48951" y="1778644"/>
            <a:ext cx="3511413" cy="263356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15ED0AC0-E70D-42E2-992C-C58D5F7C09C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536510" y="1799869"/>
            <a:ext cx="3511413" cy="263356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347BDE17-78CD-404F-B7DE-FA3B0F9812B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479809" y="1790409"/>
            <a:ext cx="3517807" cy="263835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311753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34</Words>
  <Application>Microsoft Macintosh PowerPoint</Application>
  <PresentationFormat>ワイド画面</PresentationFormat>
  <Paragraphs>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ucky R</dc:creator>
  <cp:lastModifiedBy>優樹 江下</cp:lastModifiedBy>
  <cp:revision>7</cp:revision>
  <dcterms:created xsi:type="dcterms:W3CDTF">2020-06-30T08:34:28Z</dcterms:created>
  <dcterms:modified xsi:type="dcterms:W3CDTF">2020-10-11T15:54:34Z</dcterms:modified>
</cp:coreProperties>
</file>